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A90D4E0-D324-4E57-A838-3B36D45D3E53}" v="1" dt="2026-01-07T15:23:40.1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12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517645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6386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2976075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32688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0852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1/202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9796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j-ea"/>
                <a:cs typeface="+mj-cs"/>
              </a:rPr>
              <a:t>Blood pressure and arterial stiffness in children with chronic kidney disease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j-ea"/>
              <a:cs typeface="+mj-c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8283" y="1053305"/>
            <a:ext cx="1201181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IM</a:t>
            </a:r>
            <a:r>
              <a:rPr kumimoji="0" lang="en-GB" sz="16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To examine the roles of blood pressure (BP) and kidney function in development of arterial stiffening in children with early chronic kidney disease (CKD) compared to healthy children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ESIGN &amp; OUTCOME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65A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 Light" panose="020F0302020204030204"/>
                <a:ea typeface="+mn-ea"/>
                <a:cs typeface="+mn-cs"/>
              </a:rPr>
              <a:t>Keehn et al. 2026</a:t>
            </a:r>
            <a:endParaRPr kumimoji="0" lang="en-GB" sz="1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 Light" panose="020F0302020204030204"/>
              <a:ea typeface="+mn-ea"/>
              <a:cs typeface="+mn-cs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NCLUSIO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: Renal function in early CKD does not appear to affect arterial stiffening, independent of the BP. The strong association between PWV and MAP suggests a need for careful BP control in children with CKD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326571" y="5406933"/>
            <a:ext cx="116919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rterial stiffening in children with early chronic kidney disease is associated with blood pressure but not decline in kidney function: A longitudinal study from the HOT-KID cohort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srgbClr val="003969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53A1721B-E106-A5D1-4EA9-052A20DBE0B1}"/>
              </a:ext>
            </a:extLst>
          </p:cNvPr>
          <p:cNvSpPr/>
          <p:nvPr/>
        </p:nvSpPr>
        <p:spPr>
          <a:xfrm>
            <a:off x="496373" y="4346565"/>
            <a:ext cx="201342" cy="4823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BD388714-4DCB-954A-092A-DFB2200727FA}"/>
              </a:ext>
            </a:extLst>
          </p:cNvPr>
          <p:cNvSpPr/>
          <p:nvPr/>
        </p:nvSpPr>
        <p:spPr>
          <a:xfrm>
            <a:off x="240317" y="3183607"/>
            <a:ext cx="208148" cy="4823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0824DE1-345D-4448-BB6F-61DAA2BA3009}"/>
              </a:ext>
            </a:extLst>
          </p:cNvPr>
          <p:cNvSpPr/>
          <p:nvPr/>
        </p:nvSpPr>
        <p:spPr>
          <a:xfrm>
            <a:off x="783135" y="2906160"/>
            <a:ext cx="1548000" cy="103722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45 healthy childre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423C2CC-751F-E196-D159-2357DF97A3BE}"/>
              </a:ext>
            </a:extLst>
          </p:cNvPr>
          <p:cNvSpPr/>
          <p:nvPr/>
        </p:nvSpPr>
        <p:spPr>
          <a:xfrm>
            <a:off x="783135" y="4083640"/>
            <a:ext cx="1548000" cy="1008178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06 children with CKD stage 1-3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F06E55A-119E-FF83-F6B3-A2613EDE0420}"/>
              </a:ext>
            </a:extLst>
          </p:cNvPr>
          <p:cNvCxnSpPr>
            <a:cxnSpLocks/>
          </p:cNvCxnSpPr>
          <p:nvPr/>
        </p:nvCxnSpPr>
        <p:spPr>
          <a:xfrm>
            <a:off x="2547353" y="4025185"/>
            <a:ext cx="626329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3C0A31FD-7417-6CD3-6739-8EB7DA9C4164}"/>
              </a:ext>
            </a:extLst>
          </p:cNvPr>
          <p:cNvSpPr/>
          <p:nvPr/>
        </p:nvSpPr>
        <p:spPr>
          <a:xfrm>
            <a:off x="3173682" y="2628731"/>
            <a:ext cx="2356343" cy="46509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wo measurements of: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829E45AD-A14D-5CFC-EF39-0B392DE04F80}"/>
              </a:ext>
            </a:extLst>
          </p:cNvPr>
          <p:cNvCxnSpPr>
            <a:cxnSpLocks/>
          </p:cNvCxnSpPr>
          <p:nvPr/>
        </p:nvCxnSpPr>
        <p:spPr>
          <a:xfrm>
            <a:off x="5530025" y="4025185"/>
            <a:ext cx="612000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0" name="Picture 29" descr="A graph of a graph with red and blue lines&#10;&#10;AI-generated content may be incorrect.">
            <a:extLst>
              <a:ext uri="{FF2B5EF4-FFF2-40B4-BE49-F238E27FC236}">
                <a16:creationId xmlns:a16="http://schemas.microsoft.com/office/drawing/2014/main" id="{687111A0-9B16-2D55-4575-AA57131FD9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6517" y="1909564"/>
            <a:ext cx="5175036" cy="2817820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15E9C01F-259A-8C71-B1DB-8306CBD9887D}"/>
              </a:ext>
            </a:extLst>
          </p:cNvPr>
          <p:cNvSpPr/>
          <p:nvPr/>
        </p:nvSpPr>
        <p:spPr>
          <a:xfrm>
            <a:off x="3415853" y="3883058"/>
            <a:ext cx="187200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296D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rotid-femoral pulse wave velocity 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CD8E2372-2644-8C2E-725D-BE0A7F7BEF1E}"/>
              </a:ext>
            </a:extLst>
          </p:cNvPr>
          <p:cNvSpPr/>
          <p:nvPr/>
        </p:nvSpPr>
        <p:spPr>
          <a:xfrm>
            <a:off x="3415853" y="3168614"/>
            <a:ext cx="187200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1200" cap="none" spc="0" normalizeH="0" baseline="0" noProof="0" dirty="0">
                <a:ln>
                  <a:noFill/>
                </a:ln>
                <a:solidFill>
                  <a:srgbClr val="296D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ood pressure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568B9494-316C-C2E2-1ADF-1545338F849C}"/>
              </a:ext>
            </a:extLst>
          </p:cNvPr>
          <p:cNvSpPr/>
          <p:nvPr/>
        </p:nvSpPr>
        <p:spPr>
          <a:xfrm>
            <a:off x="3415853" y="4615578"/>
            <a:ext cx="187200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1" i="0" u="none" strike="noStrike" kern="1200" cap="none" spc="0" normalizeH="0" baseline="0" noProof="0" dirty="0">
                <a:ln>
                  <a:noFill/>
                </a:ln>
                <a:solidFill>
                  <a:srgbClr val="296D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GFR (CKD group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C01ACD3-0DC1-AC3F-E9AF-DB0997CCBC87}"/>
              </a:ext>
            </a:extLst>
          </p:cNvPr>
          <p:cNvSpPr txBox="1"/>
          <p:nvPr/>
        </p:nvSpPr>
        <p:spPr>
          <a:xfrm>
            <a:off x="2256071" y="1730507"/>
            <a:ext cx="4726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srgbClr val="00437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b-study analysis from HOT-KID cohor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B79F5EB-043B-D81D-CE85-7F6DEC9C8319}"/>
              </a:ext>
            </a:extLst>
          </p:cNvPr>
          <p:cNvSpPr txBox="1"/>
          <p:nvPr/>
        </p:nvSpPr>
        <p:spPr>
          <a:xfrm>
            <a:off x="6916059" y="4685680"/>
            <a:ext cx="4659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srgbClr val="00437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 children with CKD, progression of PWV is associated with MAP, not eGFR</a:t>
            </a: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9BC72384-FAB5-84E2-60E3-5C6D8BFDFE1C}"/>
              </a:ext>
            </a:extLst>
          </p:cNvPr>
          <p:cNvSpPr/>
          <p:nvPr/>
        </p:nvSpPr>
        <p:spPr>
          <a:xfrm>
            <a:off x="475900" y="3183607"/>
            <a:ext cx="208148" cy="4823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8C001B86-B050-7BE8-9285-CFECDCCCEB81}"/>
              </a:ext>
            </a:extLst>
          </p:cNvPr>
          <p:cNvSpPr/>
          <p:nvPr/>
        </p:nvSpPr>
        <p:spPr>
          <a:xfrm>
            <a:off x="254201" y="4346565"/>
            <a:ext cx="201342" cy="4823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66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ouise Keehn</dc:creator>
  <cp:lastModifiedBy>Laycock, Joseph</cp:lastModifiedBy>
  <cp:revision>4</cp:revision>
  <dcterms:created xsi:type="dcterms:W3CDTF">2025-11-30T10:03:51Z</dcterms:created>
  <dcterms:modified xsi:type="dcterms:W3CDTF">2026-01-07T15:24:59Z</dcterms:modified>
</cp:coreProperties>
</file>